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872413" cy="72183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9" autoAdjust="0"/>
    <p:restoredTop sz="94660"/>
  </p:normalViewPr>
  <p:slideViewPr>
    <p:cSldViewPr snapToGrid="0">
      <p:cViewPr varScale="1">
        <p:scale>
          <a:sx n="78" d="100"/>
          <a:sy n="78" d="100"/>
        </p:scale>
        <p:origin x="137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0431" y="1181339"/>
            <a:ext cx="6691551" cy="2513060"/>
          </a:xfrm>
        </p:spPr>
        <p:txBody>
          <a:bodyPr anchor="b"/>
          <a:lstStyle>
            <a:lvl1pPr algn="ctr">
              <a:defRPr sz="516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4052" y="3791312"/>
            <a:ext cx="5904310" cy="1742766"/>
          </a:xfrm>
        </p:spPr>
        <p:txBody>
          <a:bodyPr/>
          <a:lstStyle>
            <a:lvl1pPr marL="0" indent="0" algn="ctr">
              <a:buNone/>
              <a:defRPr sz="2066"/>
            </a:lvl1pPr>
            <a:lvl2pPr marL="393603" indent="0" algn="ctr">
              <a:buNone/>
              <a:defRPr sz="1722"/>
            </a:lvl2pPr>
            <a:lvl3pPr marL="787207" indent="0" algn="ctr">
              <a:buNone/>
              <a:defRPr sz="1550"/>
            </a:lvl3pPr>
            <a:lvl4pPr marL="1180810" indent="0" algn="ctr">
              <a:buNone/>
              <a:defRPr sz="1377"/>
            </a:lvl4pPr>
            <a:lvl5pPr marL="1574414" indent="0" algn="ctr">
              <a:buNone/>
              <a:defRPr sz="1377"/>
            </a:lvl5pPr>
            <a:lvl6pPr marL="1968017" indent="0" algn="ctr">
              <a:buNone/>
              <a:defRPr sz="1377"/>
            </a:lvl6pPr>
            <a:lvl7pPr marL="2361621" indent="0" algn="ctr">
              <a:buNone/>
              <a:defRPr sz="1377"/>
            </a:lvl7pPr>
            <a:lvl8pPr marL="2755224" indent="0" algn="ctr">
              <a:buNone/>
              <a:defRPr sz="1377"/>
            </a:lvl8pPr>
            <a:lvl9pPr marL="3148828" indent="0" algn="ctr">
              <a:buNone/>
              <a:defRPr sz="1377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28809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8712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3696" y="384311"/>
            <a:ext cx="1697489" cy="61172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1229" y="384311"/>
            <a:ext cx="4994062" cy="61172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3391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13892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7129" y="1799580"/>
            <a:ext cx="6789956" cy="3002638"/>
          </a:xfrm>
        </p:spPr>
        <p:txBody>
          <a:bodyPr anchor="b"/>
          <a:lstStyle>
            <a:lvl1pPr>
              <a:defRPr sz="516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7129" y="4830624"/>
            <a:ext cx="6789956" cy="1579016"/>
          </a:xfrm>
        </p:spPr>
        <p:txBody>
          <a:bodyPr/>
          <a:lstStyle>
            <a:lvl1pPr marL="0" indent="0">
              <a:buNone/>
              <a:defRPr sz="2066">
                <a:solidFill>
                  <a:schemeClr val="tx1"/>
                </a:solidFill>
              </a:defRPr>
            </a:lvl1pPr>
            <a:lvl2pPr marL="393603" indent="0">
              <a:buNone/>
              <a:defRPr sz="1722">
                <a:solidFill>
                  <a:schemeClr val="tx1">
                    <a:tint val="75000"/>
                  </a:schemeClr>
                </a:solidFill>
              </a:defRPr>
            </a:lvl2pPr>
            <a:lvl3pPr marL="787207" indent="0">
              <a:buNone/>
              <a:defRPr sz="1550">
                <a:solidFill>
                  <a:schemeClr val="tx1">
                    <a:tint val="75000"/>
                  </a:schemeClr>
                </a:solidFill>
              </a:defRPr>
            </a:lvl3pPr>
            <a:lvl4pPr marL="1180810" indent="0">
              <a:buNone/>
              <a:defRPr sz="1377">
                <a:solidFill>
                  <a:schemeClr val="tx1">
                    <a:tint val="75000"/>
                  </a:schemeClr>
                </a:solidFill>
              </a:defRPr>
            </a:lvl4pPr>
            <a:lvl5pPr marL="1574414" indent="0">
              <a:buNone/>
              <a:defRPr sz="1377">
                <a:solidFill>
                  <a:schemeClr val="tx1">
                    <a:tint val="75000"/>
                  </a:schemeClr>
                </a:solidFill>
              </a:defRPr>
            </a:lvl5pPr>
            <a:lvl6pPr marL="1968017" indent="0">
              <a:buNone/>
              <a:defRPr sz="1377">
                <a:solidFill>
                  <a:schemeClr val="tx1">
                    <a:tint val="75000"/>
                  </a:schemeClr>
                </a:solidFill>
              </a:defRPr>
            </a:lvl6pPr>
            <a:lvl7pPr marL="2361621" indent="0">
              <a:buNone/>
              <a:defRPr sz="1377">
                <a:solidFill>
                  <a:schemeClr val="tx1">
                    <a:tint val="75000"/>
                  </a:schemeClr>
                </a:solidFill>
              </a:defRPr>
            </a:lvl7pPr>
            <a:lvl8pPr marL="2755224" indent="0">
              <a:buNone/>
              <a:defRPr sz="1377">
                <a:solidFill>
                  <a:schemeClr val="tx1">
                    <a:tint val="75000"/>
                  </a:schemeClr>
                </a:solidFill>
              </a:defRPr>
            </a:lvl8pPr>
            <a:lvl9pPr marL="3148828" indent="0">
              <a:buNone/>
              <a:defRPr sz="137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35113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1228" y="1921555"/>
            <a:ext cx="3345776" cy="457998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85409" y="1921555"/>
            <a:ext cx="3345776" cy="457998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63042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2254" y="384312"/>
            <a:ext cx="6789956" cy="13952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2255" y="1769502"/>
            <a:ext cx="3330399" cy="867206"/>
          </a:xfrm>
        </p:spPr>
        <p:txBody>
          <a:bodyPr anchor="b"/>
          <a:lstStyle>
            <a:lvl1pPr marL="0" indent="0">
              <a:buNone/>
              <a:defRPr sz="2066" b="1"/>
            </a:lvl1pPr>
            <a:lvl2pPr marL="393603" indent="0">
              <a:buNone/>
              <a:defRPr sz="1722" b="1"/>
            </a:lvl2pPr>
            <a:lvl3pPr marL="787207" indent="0">
              <a:buNone/>
              <a:defRPr sz="1550" b="1"/>
            </a:lvl3pPr>
            <a:lvl4pPr marL="1180810" indent="0">
              <a:buNone/>
              <a:defRPr sz="1377" b="1"/>
            </a:lvl4pPr>
            <a:lvl5pPr marL="1574414" indent="0">
              <a:buNone/>
              <a:defRPr sz="1377" b="1"/>
            </a:lvl5pPr>
            <a:lvl6pPr marL="1968017" indent="0">
              <a:buNone/>
              <a:defRPr sz="1377" b="1"/>
            </a:lvl6pPr>
            <a:lvl7pPr marL="2361621" indent="0">
              <a:buNone/>
              <a:defRPr sz="1377" b="1"/>
            </a:lvl7pPr>
            <a:lvl8pPr marL="2755224" indent="0">
              <a:buNone/>
              <a:defRPr sz="1377" b="1"/>
            </a:lvl8pPr>
            <a:lvl9pPr marL="3148828" indent="0">
              <a:buNone/>
              <a:defRPr sz="137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2255" y="2636707"/>
            <a:ext cx="3330399" cy="38782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85409" y="1769502"/>
            <a:ext cx="3346801" cy="867206"/>
          </a:xfrm>
        </p:spPr>
        <p:txBody>
          <a:bodyPr anchor="b"/>
          <a:lstStyle>
            <a:lvl1pPr marL="0" indent="0">
              <a:buNone/>
              <a:defRPr sz="2066" b="1"/>
            </a:lvl1pPr>
            <a:lvl2pPr marL="393603" indent="0">
              <a:buNone/>
              <a:defRPr sz="1722" b="1"/>
            </a:lvl2pPr>
            <a:lvl3pPr marL="787207" indent="0">
              <a:buNone/>
              <a:defRPr sz="1550" b="1"/>
            </a:lvl3pPr>
            <a:lvl4pPr marL="1180810" indent="0">
              <a:buNone/>
              <a:defRPr sz="1377" b="1"/>
            </a:lvl4pPr>
            <a:lvl5pPr marL="1574414" indent="0">
              <a:buNone/>
              <a:defRPr sz="1377" b="1"/>
            </a:lvl5pPr>
            <a:lvl6pPr marL="1968017" indent="0">
              <a:buNone/>
              <a:defRPr sz="1377" b="1"/>
            </a:lvl6pPr>
            <a:lvl7pPr marL="2361621" indent="0">
              <a:buNone/>
              <a:defRPr sz="1377" b="1"/>
            </a:lvl7pPr>
            <a:lvl8pPr marL="2755224" indent="0">
              <a:buNone/>
              <a:defRPr sz="1377" b="1"/>
            </a:lvl8pPr>
            <a:lvl9pPr marL="3148828" indent="0">
              <a:buNone/>
              <a:defRPr sz="1377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85409" y="2636707"/>
            <a:ext cx="3346801" cy="38782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47272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7528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0321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2254" y="481224"/>
            <a:ext cx="2539058" cy="1684285"/>
          </a:xfrm>
        </p:spPr>
        <p:txBody>
          <a:bodyPr anchor="b"/>
          <a:lstStyle>
            <a:lvl1pPr>
              <a:defRPr sz="275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46801" y="1039312"/>
            <a:ext cx="3985409" cy="5129716"/>
          </a:xfrm>
        </p:spPr>
        <p:txBody>
          <a:bodyPr/>
          <a:lstStyle>
            <a:lvl1pPr>
              <a:defRPr sz="2755"/>
            </a:lvl1pPr>
            <a:lvl2pPr>
              <a:defRPr sz="2411"/>
            </a:lvl2pPr>
            <a:lvl3pPr>
              <a:defRPr sz="2066"/>
            </a:lvl3pPr>
            <a:lvl4pPr>
              <a:defRPr sz="1722"/>
            </a:lvl4pPr>
            <a:lvl5pPr>
              <a:defRPr sz="1722"/>
            </a:lvl5pPr>
            <a:lvl6pPr>
              <a:defRPr sz="1722"/>
            </a:lvl6pPr>
            <a:lvl7pPr>
              <a:defRPr sz="1722"/>
            </a:lvl7pPr>
            <a:lvl8pPr>
              <a:defRPr sz="1722"/>
            </a:lvl8pPr>
            <a:lvl9pPr>
              <a:defRPr sz="1722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2254" y="2165509"/>
            <a:ext cx="2539058" cy="4011873"/>
          </a:xfrm>
        </p:spPr>
        <p:txBody>
          <a:bodyPr/>
          <a:lstStyle>
            <a:lvl1pPr marL="0" indent="0">
              <a:buNone/>
              <a:defRPr sz="1377"/>
            </a:lvl1pPr>
            <a:lvl2pPr marL="393603" indent="0">
              <a:buNone/>
              <a:defRPr sz="1205"/>
            </a:lvl2pPr>
            <a:lvl3pPr marL="787207" indent="0">
              <a:buNone/>
              <a:defRPr sz="1033"/>
            </a:lvl3pPr>
            <a:lvl4pPr marL="1180810" indent="0">
              <a:buNone/>
              <a:defRPr sz="861"/>
            </a:lvl4pPr>
            <a:lvl5pPr marL="1574414" indent="0">
              <a:buNone/>
              <a:defRPr sz="861"/>
            </a:lvl5pPr>
            <a:lvl6pPr marL="1968017" indent="0">
              <a:buNone/>
              <a:defRPr sz="861"/>
            </a:lvl6pPr>
            <a:lvl7pPr marL="2361621" indent="0">
              <a:buNone/>
              <a:defRPr sz="861"/>
            </a:lvl7pPr>
            <a:lvl8pPr marL="2755224" indent="0">
              <a:buNone/>
              <a:defRPr sz="861"/>
            </a:lvl8pPr>
            <a:lvl9pPr marL="3148828" indent="0">
              <a:buNone/>
              <a:defRPr sz="86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0533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2254" y="481224"/>
            <a:ext cx="2539058" cy="1684285"/>
          </a:xfrm>
        </p:spPr>
        <p:txBody>
          <a:bodyPr anchor="b"/>
          <a:lstStyle>
            <a:lvl1pPr>
              <a:defRPr sz="275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46801" y="1039312"/>
            <a:ext cx="3985409" cy="5129716"/>
          </a:xfrm>
        </p:spPr>
        <p:txBody>
          <a:bodyPr anchor="t"/>
          <a:lstStyle>
            <a:lvl1pPr marL="0" indent="0">
              <a:buNone/>
              <a:defRPr sz="2755"/>
            </a:lvl1pPr>
            <a:lvl2pPr marL="393603" indent="0">
              <a:buNone/>
              <a:defRPr sz="2411"/>
            </a:lvl2pPr>
            <a:lvl3pPr marL="787207" indent="0">
              <a:buNone/>
              <a:defRPr sz="2066"/>
            </a:lvl3pPr>
            <a:lvl4pPr marL="1180810" indent="0">
              <a:buNone/>
              <a:defRPr sz="1722"/>
            </a:lvl4pPr>
            <a:lvl5pPr marL="1574414" indent="0">
              <a:buNone/>
              <a:defRPr sz="1722"/>
            </a:lvl5pPr>
            <a:lvl6pPr marL="1968017" indent="0">
              <a:buNone/>
              <a:defRPr sz="1722"/>
            </a:lvl6pPr>
            <a:lvl7pPr marL="2361621" indent="0">
              <a:buNone/>
              <a:defRPr sz="1722"/>
            </a:lvl7pPr>
            <a:lvl8pPr marL="2755224" indent="0">
              <a:buNone/>
              <a:defRPr sz="1722"/>
            </a:lvl8pPr>
            <a:lvl9pPr marL="3148828" indent="0">
              <a:buNone/>
              <a:defRPr sz="1722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2254" y="2165509"/>
            <a:ext cx="2539058" cy="4011873"/>
          </a:xfrm>
        </p:spPr>
        <p:txBody>
          <a:bodyPr/>
          <a:lstStyle>
            <a:lvl1pPr marL="0" indent="0">
              <a:buNone/>
              <a:defRPr sz="1377"/>
            </a:lvl1pPr>
            <a:lvl2pPr marL="393603" indent="0">
              <a:buNone/>
              <a:defRPr sz="1205"/>
            </a:lvl2pPr>
            <a:lvl3pPr marL="787207" indent="0">
              <a:buNone/>
              <a:defRPr sz="1033"/>
            </a:lvl3pPr>
            <a:lvl4pPr marL="1180810" indent="0">
              <a:buNone/>
              <a:defRPr sz="861"/>
            </a:lvl4pPr>
            <a:lvl5pPr marL="1574414" indent="0">
              <a:buNone/>
              <a:defRPr sz="861"/>
            </a:lvl5pPr>
            <a:lvl6pPr marL="1968017" indent="0">
              <a:buNone/>
              <a:defRPr sz="861"/>
            </a:lvl6pPr>
            <a:lvl7pPr marL="2361621" indent="0">
              <a:buNone/>
              <a:defRPr sz="861"/>
            </a:lvl7pPr>
            <a:lvl8pPr marL="2755224" indent="0">
              <a:buNone/>
              <a:defRPr sz="861"/>
            </a:lvl8pPr>
            <a:lvl9pPr marL="3148828" indent="0">
              <a:buNone/>
              <a:defRPr sz="86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47342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1229" y="384312"/>
            <a:ext cx="6789956" cy="139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229" y="1921555"/>
            <a:ext cx="6789956" cy="45799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1228" y="6690355"/>
            <a:ext cx="1771293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141D0-8A77-4553-ADC9-E2AC0E3A6CF9}" type="datetimeFigureOut">
              <a:rPr lang="en-CA" smtClean="0"/>
              <a:t>09/11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07737" y="6690355"/>
            <a:ext cx="2656939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59892" y="6690355"/>
            <a:ext cx="1771293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24B74-3C2A-448E-84A1-B043F26B3DA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94499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87207" rtl="0" eaLnBrk="1" latinLnBrk="0" hangingPunct="1">
        <a:lnSpc>
          <a:spcPct val="90000"/>
        </a:lnSpc>
        <a:spcBef>
          <a:spcPct val="0"/>
        </a:spcBef>
        <a:buNone/>
        <a:defRPr sz="378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6802" indent="-196802" algn="l" defTabSz="787207" rtl="0" eaLnBrk="1" latinLnBrk="0" hangingPunct="1">
        <a:lnSpc>
          <a:spcPct val="90000"/>
        </a:lnSpc>
        <a:spcBef>
          <a:spcPts val="861"/>
        </a:spcBef>
        <a:buFont typeface="Arial" panose="020B0604020202020204" pitchFamily="34" charset="0"/>
        <a:buChar char="•"/>
        <a:defRPr sz="2411" kern="1200">
          <a:solidFill>
            <a:schemeClr val="tx1"/>
          </a:solidFill>
          <a:latin typeface="+mn-lt"/>
          <a:ea typeface="+mn-ea"/>
          <a:cs typeface="+mn-cs"/>
        </a:defRPr>
      </a:lvl1pPr>
      <a:lvl2pPr marL="590405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2066" kern="1200">
          <a:solidFill>
            <a:schemeClr val="tx1"/>
          </a:solidFill>
          <a:latin typeface="+mn-lt"/>
          <a:ea typeface="+mn-ea"/>
          <a:cs typeface="+mn-cs"/>
        </a:defRPr>
      </a:lvl2pPr>
      <a:lvl3pPr marL="984009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1722" kern="1200">
          <a:solidFill>
            <a:schemeClr val="tx1"/>
          </a:solidFill>
          <a:latin typeface="+mn-lt"/>
          <a:ea typeface="+mn-ea"/>
          <a:cs typeface="+mn-cs"/>
        </a:defRPr>
      </a:lvl3pPr>
      <a:lvl4pPr marL="1377612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1550" kern="1200">
          <a:solidFill>
            <a:schemeClr val="tx1"/>
          </a:solidFill>
          <a:latin typeface="+mn-lt"/>
          <a:ea typeface="+mn-ea"/>
          <a:cs typeface="+mn-cs"/>
        </a:defRPr>
      </a:lvl4pPr>
      <a:lvl5pPr marL="1771216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1550" kern="1200">
          <a:solidFill>
            <a:schemeClr val="tx1"/>
          </a:solidFill>
          <a:latin typeface="+mn-lt"/>
          <a:ea typeface="+mn-ea"/>
          <a:cs typeface="+mn-cs"/>
        </a:defRPr>
      </a:lvl5pPr>
      <a:lvl6pPr marL="2164819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1550" kern="1200">
          <a:solidFill>
            <a:schemeClr val="tx1"/>
          </a:solidFill>
          <a:latin typeface="+mn-lt"/>
          <a:ea typeface="+mn-ea"/>
          <a:cs typeface="+mn-cs"/>
        </a:defRPr>
      </a:lvl6pPr>
      <a:lvl7pPr marL="2558423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1550" kern="1200">
          <a:solidFill>
            <a:schemeClr val="tx1"/>
          </a:solidFill>
          <a:latin typeface="+mn-lt"/>
          <a:ea typeface="+mn-ea"/>
          <a:cs typeface="+mn-cs"/>
        </a:defRPr>
      </a:lvl7pPr>
      <a:lvl8pPr marL="2952026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1550" kern="1200">
          <a:solidFill>
            <a:schemeClr val="tx1"/>
          </a:solidFill>
          <a:latin typeface="+mn-lt"/>
          <a:ea typeface="+mn-ea"/>
          <a:cs typeface="+mn-cs"/>
        </a:defRPr>
      </a:lvl8pPr>
      <a:lvl9pPr marL="3345630" indent="-196802" algn="l" defTabSz="787207" rtl="0" eaLnBrk="1" latinLnBrk="0" hangingPunct="1">
        <a:lnSpc>
          <a:spcPct val="90000"/>
        </a:lnSpc>
        <a:spcBef>
          <a:spcPts val="430"/>
        </a:spcBef>
        <a:buFont typeface="Arial" panose="020B0604020202020204" pitchFamily="34" charset="0"/>
        <a:buChar char="•"/>
        <a:defRPr sz="15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1pPr>
      <a:lvl2pPr marL="393603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2pPr>
      <a:lvl3pPr marL="787207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3pPr>
      <a:lvl4pPr marL="1180810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4pPr>
      <a:lvl5pPr marL="1574414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5pPr>
      <a:lvl6pPr marL="1968017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6pPr>
      <a:lvl7pPr marL="2361621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7pPr>
      <a:lvl8pPr marL="2755224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8pPr>
      <a:lvl9pPr marL="3148828" algn="l" defTabSz="787207" rtl="0" eaLnBrk="1" latinLnBrk="0" hangingPunct="1">
        <a:defRPr sz="15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0" name="Picture 136" descr="A2780+DXL for A2780vsA2780DXL 2100 expert_EukaryoteTotal RNA Nano_DE34903748_2012-06-18_10-51-54UNFLAGGEDINDIVIDUAL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539" y="1143001"/>
            <a:ext cx="1577975" cy="214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sp>
        <p:nvSpPr>
          <p:cNvPr id="1153" name="Text Box 137"/>
          <p:cNvSpPr txBox="1">
            <a:spLocks noChangeArrowheads="1"/>
          </p:cNvSpPr>
          <p:nvPr/>
        </p:nvSpPr>
        <p:spPr bwMode="auto">
          <a:xfrm rot="16200000">
            <a:off x="-247648" y="869951"/>
            <a:ext cx="914400" cy="171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5" name="Text Box 138"/>
          <p:cNvSpPr txBox="1">
            <a:spLocks noChangeArrowheads="1"/>
          </p:cNvSpPr>
          <p:nvPr/>
        </p:nvSpPr>
        <p:spPr bwMode="auto">
          <a:xfrm rot="16200000">
            <a:off x="24608" y="870745"/>
            <a:ext cx="914400" cy="16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005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7" name="Text Box 139"/>
          <p:cNvSpPr txBox="1">
            <a:spLocks noChangeArrowheads="1"/>
          </p:cNvSpPr>
          <p:nvPr/>
        </p:nvSpPr>
        <p:spPr bwMode="auto">
          <a:xfrm rot="16200000">
            <a:off x="284958" y="870745"/>
            <a:ext cx="914400" cy="16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2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9" name="AutoShape 140"/>
          <p:cNvSpPr>
            <a:spLocks/>
          </p:cNvSpPr>
          <p:nvPr/>
        </p:nvSpPr>
        <p:spPr bwMode="auto">
          <a:xfrm rot="16200000">
            <a:off x="450058" y="362744"/>
            <a:ext cx="120650" cy="750888"/>
          </a:xfrm>
          <a:prstGeom prst="rightBrace">
            <a:avLst>
              <a:gd name="adj1" fmla="val 51864"/>
              <a:gd name="adj2" fmla="val 50000"/>
            </a:avLst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61" name="Text Box 141"/>
          <p:cNvSpPr txBox="1">
            <a:spLocks noChangeArrowheads="1"/>
          </p:cNvSpPr>
          <p:nvPr/>
        </p:nvSpPr>
        <p:spPr bwMode="auto">
          <a:xfrm>
            <a:off x="333377" y="452438"/>
            <a:ext cx="371475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8 hr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166" name="Picture 142" descr="A2780DXL+DXL for A2780vsA2780DXL 2100 expert_EukaryoteTotal RNA Nano_DE34903748_2012-06-18_10-51-54UNFLAGGEDINDIVIDUAL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6339" y="1112838"/>
            <a:ext cx="1579563" cy="214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sp>
        <p:nvSpPr>
          <p:cNvPr id="1162" name="Text Box 143"/>
          <p:cNvSpPr txBox="1">
            <a:spLocks noChangeArrowheads="1"/>
          </p:cNvSpPr>
          <p:nvPr/>
        </p:nvSpPr>
        <p:spPr bwMode="auto">
          <a:xfrm>
            <a:off x="661989" y="219076"/>
            <a:ext cx="493713" cy="193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278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1163" name="Object 11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6806275"/>
              </p:ext>
            </p:extLst>
          </p:nvPr>
        </p:nvGraphicFramePr>
        <p:xfrm>
          <a:off x="5160964" y="1112838"/>
          <a:ext cx="1743075" cy="2327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" name="Acrobat Document" r:id="rId5" imgW="4867078" imgH="1333327" progId="Acrobat.Document.11">
                  <p:embed/>
                </p:oleObj>
              </mc:Choice>
              <mc:Fallback>
                <p:oleObj name="Acrobat Document" r:id="rId5" imgW="4867078" imgH="1333327" progId="Acrobat.Document.11">
                  <p:embed/>
                  <p:pic>
                    <p:nvPicPr>
                      <p:cNvPr id="0" name="Object 14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60964" y="1112838"/>
                        <a:ext cx="1743075" cy="23272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 algn="in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4" name="Text Box 145"/>
          <p:cNvSpPr txBox="1">
            <a:spLocks noChangeArrowheads="1"/>
          </p:cNvSpPr>
          <p:nvPr/>
        </p:nvSpPr>
        <p:spPr bwMode="auto">
          <a:xfrm rot="16200000">
            <a:off x="5060158" y="573882"/>
            <a:ext cx="914400" cy="16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5" name="Text Box 146"/>
          <p:cNvSpPr txBox="1">
            <a:spLocks noChangeArrowheads="1"/>
          </p:cNvSpPr>
          <p:nvPr/>
        </p:nvSpPr>
        <p:spPr bwMode="auto">
          <a:xfrm rot="16200000">
            <a:off x="5384008" y="573882"/>
            <a:ext cx="914400" cy="16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7" name="Text Box 147"/>
          <p:cNvSpPr txBox="1">
            <a:spLocks noChangeArrowheads="1"/>
          </p:cNvSpPr>
          <p:nvPr/>
        </p:nvSpPr>
        <p:spPr bwMode="auto">
          <a:xfrm rot="16200000">
            <a:off x="5714208" y="578645"/>
            <a:ext cx="914400" cy="16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8" name="Text Box 148"/>
          <p:cNvSpPr txBox="1">
            <a:spLocks noChangeArrowheads="1"/>
          </p:cNvSpPr>
          <p:nvPr/>
        </p:nvSpPr>
        <p:spPr bwMode="auto">
          <a:xfrm rot="16200000">
            <a:off x="6052346" y="578644"/>
            <a:ext cx="914400" cy="16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9" name="AutoShape 149"/>
          <p:cNvSpPr>
            <a:spLocks/>
          </p:cNvSpPr>
          <p:nvPr/>
        </p:nvSpPr>
        <p:spPr bwMode="auto">
          <a:xfrm rot="16200000">
            <a:off x="5642771" y="262732"/>
            <a:ext cx="131762" cy="647700"/>
          </a:xfrm>
          <a:prstGeom prst="rightBrace">
            <a:avLst>
              <a:gd name="adj1" fmla="val 40964"/>
              <a:gd name="adj2" fmla="val 50000"/>
            </a:avLst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70" name="AutoShape 150"/>
          <p:cNvSpPr>
            <a:spLocks/>
          </p:cNvSpPr>
          <p:nvPr/>
        </p:nvSpPr>
        <p:spPr bwMode="auto">
          <a:xfrm rot="16200000">
            <a:off x="6304758" y="262732"/>
            <a:ext cx="131762" cy="647700"/>
          </a:xfrm>
          <a:prstGeom prst="rightBrace">
            <a:avLst>
              <a:gd name="adj1" fmla="val 40964"/>
              <a:gd name="adj2" fmla="val 50000"/>
            </a:avLst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71" name="Text Box 151"/>
          <p:cNvSpPr txBox="1">
            <a:spLocks noChangeArrowheads="1"/>
          </p:cNvSpPr>
          <p:nvPr/>
        </p:nvSpPr>
        <p:spPr bwMode="auto">
          <a:xfrm>
            <a:off x="5421314" y="328613"/>
            <a:ext cx="490538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278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72" name="Text Box 152"/>
          <p:cNvSpPr txBox="1">
            <a:spLocks noChangeArrowheads="1"/>
          </p:cNvSpPr>
          <p:nvPr/>
        </p:nvSpPr>
        <p:spPr bwMode="auto">
          <a:xfrm>
            <a:off x="5978527" y="330201"/>
            <a:ext cx="842962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2780CB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173" name="Group 153"/>
          <p:cNvGrpSpPr>
            <a:grpSpLocks/>
          </p:cNvGrpSpPr>
          <p:nvPr/>
        </p:nvGrpSpPr>
        <p:grpSpPr bwMode="auto">
          <a:xfrm>
            <a:off x="1192214" y="3603626"/>
            <a:ext cx="957263" cy="3055937"/>
            <a:chOff x="107375591" y="108917257"/>
            <a:chExt cx="957005" cy="3054686"/>
          </a:xfrm>
        </p:grpSpPr>
        <p:pic>
          <p:nvPicPr>
            <p:cNvPr id="1178" name="Picture 154" descr="A2780DXL 5uM CBN-PIC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7532015" y="109509971"/>
              <a:ext cx="564497" cy="22671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sp>
          <p:nvSpPr>
            <p:cNvPr id="1174" name="Text Box 155"/>
            <p:cNvSpPr txBox="1">
              <a:spLocks noChangeArrowheads="1"/>
            </p:cNvSpPr>
            <p:nvPr/>
          </p:nvSpPr>
          <p:spPr bwMode="auto">
            <a:xfrm rot="-46346803">
              <a:off x="107457953" y="109289417"/>
              <a:ext cx="914400" cy="1700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0 </a:t>
              </a:r>
              <a:r>
                <a:rPr kumimoji="0" lang="en-US" altLang="en-US" sz="12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µ</a:t>
              </a: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 CB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5" name="Text Box 156"/>
            <p:cNvSpPr txBox="1">
              <a:spLocks noChangeArrowheads="1"/>
            </p:cNvSpPr>
            <p:nvPr/>
          </p:nvSpPr>
          <p:spPr bwMode="auto">
            <a:xfrm rot="-46346803">
              <a:off x="107753610" y="109289417"/>
              <a:ext cx="914400" cy="1700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5 </a:t>
              </a:r>
              <a:r>
                <a:rPr kumimoji="0" lang="en-US" altLang="en-US" sz="12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µ</a:t>
              </a: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 CB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6" name="Text Box 157"/>
            <p:cNvSpPr txBox="1">
              <a:spLocks noChangeArrowheads="1"/>
            </p:cNvSpPr>
            <p:nvPr/>
          </p:nvSpPr>
          <p:spPr bwMode="auto">
            <a:xfrm>
              <a:off x="107375591" y="111777343"/>
              <a:ext cx="957005" cy="194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2780DX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177" name="AutoShape 158"/>
          <p:cNvSpPr>
            <a:spLocks/>
          </p:cNvSpPr>
          <p:nvPr/>
        </p:nvSpPr>
        <p:spPr bwMode="auto">
          <a:xfrm rot="16200000">
            <a:off x="1247777" y="366713"/>
            <a:ext cx="122238" cy="750887"/>
          </a:xfrm>
          <a:prstGeom prst="rightBrace">
            <a:avLst>
              <a:gd name="adj1" fmla="val 51190"/>
              <a:gd name="adj2" fmla="val 50000"/>
            </a:avLst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79" name="Text Box 159"/>
          <p:cNvSpPr txBox="1">
            <a:spLocks noChangeArrowheads="1"/>
          </p:cNvSpPr>
          <p:nvPr/>
        </p:nvSpPr>
        <p:spPr bwMode="auto">
          <a:xfrm>
            <a:off x="1131889" y="455613"/>
            <a:ext cx="371475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72 hr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0" name="Text Box 160"/>
          <p:cNvSpPr txBox="1">
            <a:spLocks noChangeArrowheads="1"/>
          </p:cNvSpPr>
          <p:nvPr/>
        </p:nvSpPr>
        <p:spPr bwMode="auto">
          <a:xfrm>
            <a:off x="2892427" y="201613"/>
            <a:ext cx="865187" cy="214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2780DXL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185" name="AutoShape 161"/>
          <p:cNvCxnSpPr>
            <a:cxnSpLocks noChangeShapeType="1"/>
          </p:cNvCxnSpPr>
          <p:nvPr/>
        </p:nvCxnSpPr>
        <p:spPr bwMode="auto">
          <a:xfrm flipH="1">
            <a:off x="1649414" y="1938338"/>
            <a:ext cx="179388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181" name="Text Box 162"/>
          <p:cNvSpPr txBox="1">
            <a:spLocks noChangeArrowheads="1"/>
          </p:cNvSpPr>
          <p:nvPr/>
        </p:nvSpPr>
        <p:spPr bwMode="auto">
          <a:xfrm>
            <a:off x="1803402" y="1830388"/>
            <a:ext cx="785812" cy="153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187" name="AutoShape 163"/>
          <p:cNvCxnSpPr>
            <a:cxnSpLocks noChangeShapeType="1"/>
          </p:cNvCxnSpPr>
          <p:nvPr/>
        </p:nvCxnSpPr>
        <p:spPr bwMode="auto">
          <a:xfrm flipH="1">
            <a:off x="1649414" y="2290763"/>
            <a:ext cx="180975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182" name="Text Box 164"/>
          <p:cNvSpPr txBox="1">
            <a:spLocks noChangeArrowheads="1"/>
          </p:cNvSpPr>
          <p:nvPr/>
        </p:nvSpPr>
        <p:spPr bwMode="auto">
          <a:xfrm>
            <a:off x="1804989" y="2189163"/>
            <a:ext cx="784225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3" name="Text Box 165"/>
          <p:cNvSpPr txBox="1">
            <a:spLocks noChangeArrowheads="1"/>
          </p:cNvSpPr>
          <p:nvPr/>
        </p:nvSpPr>
        <p:spPr bwMode="auto">
          <a:xfrm rot="16200000">
            <a:off x="532608" y="875507"/>
            <a:ext cx="914400" cy="16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4" name="Text Box 166"/>
          <p:cNvSpPr txBox="1">
            <a:spLocks noChangeArrowheads="1"/>
          </p:cNvSpPr>
          <p:nvPr/>
        </p:nvSpPr>
        <p:spPr bwMode="auto">
          <a:xfrm rot="16200000">
            <a:off x="804864" y="874713"/>
            <a:ext cx="914400" cy="171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005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6" name="Text Box 167"/>
          <p:cNvSpPr txBox="1">
            <a:spLocks noChangeArrowheads="1"/>
          </p:cNvSpPr>
          <p:nvPr/>
        </p:nvSpPr>
        <p:spPr bwMode="auto">
          <a:xfrm rot="16200000">
            <a:off x="1064421" y="875506"/>
            <a:ext cx="914400" cy="16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2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8" name="Text Box 168"/>
          <p:cNvSpPr txBox="1">
            <a:spLocks noChangeArrowheads="1"/>
          </p:cNvSpPr>
          <p:nvPr/>
        </p:nvSpPr>
        <p:spPr bwMode="auto">
          <a:xfrm rot="16200000">
            <a:off x="2078833" y="865982"/>
            <a:ext cx="914400" cy="16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9" name="Text Box 169"/>
          <p:cNvSpPr txBox="1">
            <a:spLocks noChangeArrowheads="1"/>
          </p:cNvSpPr>
          <p:nvPr/>
        </p:nvSpPr>
        <p:spPr bwMode="auto">
          <a:xfrm rot="16200000">
            <a:off x="2351089" y="865188"/>
            <a:ext cx="914400" cy="171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005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0" name="Text Box 170"/>
          <p:cNvSpPr txBox="1">
            <a:spLocks noChangeArrowheads="1"/>
          </p:cNvSpPr>
          <p:nvPr/>
        </p:nvSpPr>
        <p:spPr bwMode="auto">
          <a:xfrm rot="16200000">
            <a:off x="2610646" y="865981"/>
            <a:ext cx="914400" cy="16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2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1" name="AutoShape 171"/>
          <p:cNvSpPr>
            <a:spLocks/>
          </p:cNvSpPr>
          <p:nvPr/>
        </p:nvSpPr>
        <p:spPr bwMode="auto">
          <a:xfrm rot="16200000">
            <a:off x="2774952" y="357188"/>
            <a:ext cx="122238" cy="750887"/>
          </a:xfrm>
          <a:prstGeom prst="rightBrace">
            <a:avLst>
              <a:gd name="adj1" fmla="val 51190"/>
              <a:gd name="adj2" fmla="val 50000"/>
            </a:avLst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92" name="Text Box 172"/>
          <p:cNvSpPr txBox="1">
            <a:spLocks noChangeArrowheads="1"/>
          </p:cNvSpPr>
          <p:nvPr/>
        </p:nvSpPr>
        <p:spPr bwMode="auto">
          <a:xfrm>
            <a:off x="2659064" y="447676"/>
            <a:ext cx="371475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8 hr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3" name="AutoShape 173"/>
          <p:cNvSpPr>
            <a:spLocks/>
          </p:cNvSpPr>
          <p:nvPr/>
        </p:nvSpPr>
        <p:spPr bwMode="auto">
          <a:xfrm rot="16200000">
            <a:off x="3575052" y="360363"/>
            <a:ext cx="120650" cy="752475"/>
          </a:xfrm>
          <a:prstGeom prst="rightBrace">
            <a:avLst>
              <a:gd name="adj1" fmla="val 51974"/>
              <a:gd name="adj2" fmla="val 50000"/>
            </a:avLst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94" name="Text Box 174"/>
          <p:cNvSpPr txBox="1">
            <a:spLocks noChangeArrowheads="1"/>
          </p:cNvSpPr>
          <p:nvPr/>
        </p:nvSpPr>
        <p:spPr bwMode="auto">
          <a:xfrm>
            <a:off x="3457577" y="450851"/>
            <a:ext cx="371475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72 hr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5" name="Text Box 175"/>
          <p:cNvSpPr txBox="1">
            <a:spLocks noChangeArrowheads="1"/>
          </p:cNvSpPr>
          <p:nvPr/>
        </p:nvSpPr>
        <p:spPr bwMode="auto">
          <a:xfrm rot="16200000">
            <a:off x="2858296" y="870744"/>
            <a:ext cx="914400" cy="16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6" name="Text Box 176"/>
          <p:cNvSpPr txBox="1">
            <a:spLocks noChangeArrowheads="1"/>
          </p:cNvSpPr>
          <p:nvPr/>
        </p:nvSpPr>
        <p:spPr bwMode="auto">
          <a:xfrm rot="16200000">
            <a:off x="3131346" y="870744"/>
            <a:ext cx="914400" cy="16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005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7" name="Text Box 177"/>
          <p:cNvSpPr txBox="1">
            <a:spLocks noChangeArrowheads="1"/>
          </p:cNvSpPr>
          <p:nvPr/>
        </p:nvSpPr>
        <p:spPr bwMode="auto">
          <a:xfrm rot="16200000">
            <a:off x="3391696" y="870744"/>
            <a:ext cx="914400" cy="16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.2 </a:t>
            </a:r>
            <a:r>
              <a:rPr kumimoji="0" lang="en-US" altLang="en-US" sz="1200" b="1" i="0" u="none" strike="noStrike" cap="none" normalizeH="0" baseline="0" noProof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µ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02" name="AutoShape 178"/>
          <p:cNvCxnSpPr>
            <a:cxnSpLocks noChangeShapeType="1"/>
          </p:cNvCxnSpPr>
          <p:nvPr/>
        </p:nvCxnSpPr>
        <p:spPr bwMode="auto">
          <a:xfrm flipH="1">
            <a:off x="3992564" y="1946276"/>
            <a:ext cx="179388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198" name="Text Box 179"/>
          <p:cNvSpPr txBox="1">
            <a:spLocks noChangeArrowheads="1"/>
          </p:cNvSpPr>
          <p:nvPr/>
        </p:nvSpPr>
        <p:spPr bwMode="auto">
          <a:xfrm>
            <a:off x="4148139" y="1836738"/>
            <a:ext cx="784225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04" name="AutoShape 180"/>
          <p:cNvCxnSpPr>
            <a:cxnSpLocks noChangeShapeType="1"/>
          </p:cNvCxnSpPr>
          <p:nvPr/>
        </p:nvCxnSpPr>
        <p:spPr bwMode="auto">
          <a:xfrm flipH="1">
            <a:off x="3992564" y="2284413"/>
            <a:ext cx="180975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199" name="Text Box 181"/>
          <p:cNvSpPr txBox="1">
            <a:spLocks noChangeArrowheads="1"/>
          </p:cNvSpPr>
          <p:nvPr/>
        </p:nvSpPr>
        <p:spPr bwMode="auto">
          <a:xfrm>
            <a:off x="4148139" y="2182813"/>
            <a:ext cx="784225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06" name="AutoShape 182"/>
          <p:cNvCxnSpPr>
            <a:cxnSpLocks noChangeShapeType="1"/>
          </p:cNvCxnSpPr>
          <p:nvPr/>
        </p:nvCxnSpPr>
        <p:spPr bwMode="auto">
          <a:xfrm flipH="1">
            <a:off x="6894514" y="1997076"/>
            <a:ext cx="179388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200" name="Text Box 183"/>
          <p:cNvSpPr txBox="1">
            <a:spLocks noChangeArrowheads="1"/>
          </p:cNvSpPr>
          <p:nvPr/>
        </p:nvSpPr>
        <p:spPr bwMode="auto">
          <a:xfrm>
            <a:off x="7048502" y="1879601"/>
            <a:ext cx="785812" cy="193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08" name="AutoShape 184"/>
          <p:cNvCxnSpPr>
            <a:cxnSpLocks noChangeShapeType="1"/>
          </p:cNvCxnSpPr>
          <p:nvPr/>
        </p:nvCxnSpPr>
        <p:spPr bwMode="auto">
          <a:xfrm flipH="1">
            <a:off x="6891339" y="2341563"/>
            <a:ext cx="179388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201" name="Text Box 185"/>
          <p:cNvSpPr txBox="1">
            <a:spLocks noChangeArrowheads="1"/>
          </p:cNvSpPr>
          <p:nvPr/>
        </p:nvSpPr>
        <p:spPr bwMode="auto">
          <a:xfrm>
            <a:off x="7046914" y="2232026"/>
            <a:ext cx="784225" cy="192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203" name="Group 186"/>
          <p:cNvGrpSpPr>
            <a:grpSpLocks/>
          </p:cNvGrpSpPr>
          <p:nvPr/>
        </p:nvGrpSpPr>
        <p:grpSpPr bwMode="auto">
          <a:xfrm>
            <a:off x="5589589" y="3594101"/>
            <a:ext cx="957263" cy="3054350"/>
            <a:chOff x="108702344" y="108917257"/>
            <a:chExt cx="957005" cy="3054686"/>
          </a:xfrm>
        </p:grpSpPr>
        <p:pic>
          <p:nvPicPr>
            <p:cNvPr id="1211" name="Picture 187" descr="2100 expert_Eukaryote Total RNA Nano_DE34903748_2013-08-20_15-35-27 (1)-A2780CBN-DXL treatment-PIC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8824085" y="109334300"/>
              <a:ext cx="600164" cy="2413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sp>
          <p:nvSpPr>
            <p:cNvPr id="1205" name="Text Box 188"/>
            <p:cNvSpPr txBox="1">
              <a:spLocks noChangeArrowheads="1"/>
            </p:cNvSpPr>
            <p:nvPr/>
          </p:nvSpPr>
          <p:spPr bwMode="auto">
            <a:xfrm>
              <a:off x="108702344" y="111777343"/>
              <a:ext cx="957005" cy="194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2780CB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7" name="Text Box 189"/>
            <p:cNvSpPr txBox="1">
              <a:spLocks noChangeArrowheads="1"/>
            </p:cNvSpPr>
            <p:nvPr/>
          </p:nvSpPr>
          <p:spPr bwMode="auto">
            <a:xfrm rot="-46346803">
              <a:off x="108804153" y="109289417"/>
              <a:ext cx="914400" cy="1700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0 </a:t>
              </a:r>
              <a:r>
                <a:rPr kumimoji="0" lang="en-US" altLang="en-US" sz="12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µ</a:t>
              </a: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 DX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9" name="Text Box 190"/>
            <p:cNvSpPr txBox="1">
              <a:spLocks noChangeArrowheads="1"/>
            </p:cNvSpPr>
            <p:nvPr/>
          </p:nvSpPr>
          <p:spPr bwMode="auto">
            <a:xfrm rot="-46346803">
              <a:off x="109087110" y="109289417"/>
              <a:ext cx="914400" cy="1700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0.2 </a:t>
              </a:r>
              <a:r>
                <a:rPr kumimoji="0" lang="en-US" altLang="en-US" sz="12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µ</a:t>
              </a: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 DX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210" name="Text Box 191"/>
          <p:cNvSpPr txBox="1">
            <a:spLocks noChangeArrowheads="1"/>
          </p:cNvSpPr>
          <p:nvPr/>
        </p:nvSpPr>
        <p:spPr bwMode="auto">
          <a:xfrm>
            <a:off x="41276" y="17463"/>
            <a:ext cx="244476" cy="25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.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12" name="Text Box 192"/>
          <p:cNvSpPr txBox="1">
            <a:spLocks noChangeArrowheads="1"/>
          </p:cNvSpPr>
          <p:nvPr/>
        </p:nvSpPr>
        <p:spPr bwMode="auto">
          <a:xfrm>
            <a:off x="4826002" y="17463"/>
            <a:ext cx="244475" cy="25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.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13" name="Text Box 193"/>
          <p:cNvSpPr txBox="1">
            <a:spLocks noChangeArrowheads="1"/>
          </p:cNvSpPr>
          <p:nvPr/>
        </p:nvSpPr>
        <p:spPr bwMode="auto">
          <a:xfrm>
            <a:off x="41276" y="3589338"/>
            <a:ext cx="244476" cy="25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.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14" name="Text Box 194"/>
          <p:cNvSpPr txBox="1">
            <a:spLocks noChangeArrowheads="1"/>
          </p:cNvSpPr>
          <p:nvPr/>
        </p:nvSpPr>
        <p:spPr bwMode="auto">
          <a:xfrm>
            <a:off x="4826002" y="3570288"/>
            <a:ext cx="244475" cy="25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.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19" name="AutoShape 195"/>
          <p:cNvCxnSpPr>
            <a:cxnSpLocks noChangeShapeType="1"/>
          </p:cNvCxnSpPr>
          <p:nvPr/>
        </p:nvCxnSpPr>
        <p:spPr bwMode="auto">
          <a:xfrm flipH="1">
            <a:off x="1912939" y="5100638"/>
            <a:ext cx="180975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215" name="Text Box 196"/>
          <p:cNvSpPr txBox="1">
            <a:spLocks noChangeArrowheads="1"/>
          </p:cNvSpPr>
          <p:nvPr/>
        </p:nvSpPr>
        <p:spPr bwMode="auto">
          <a:xfrm>
            <a:off x="2068514" y="4991101"/>
            <a:ext cx="784225" cy="185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21" name="AutoShape 197"/>
          <p:cNvCxnSpPr>
            <a:cxnSpLocks noChangeShapeType="1"/>
          </p:cNvCxnSpPr>
          <p:nvPr/>
        </p:nvCxnSpPr>
        <p:spPr bwMode="auto">
          <a:xfrm flipH="1">
            <a:off x="1914527" y="5453063"/>
            <a:ext cx="179387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216" name="Text Box 198"/>
          <p:cNvSpPr txBox="1">
            <a:spLocks noChangeArrowheads="1"/>
          </p:cNvSpPr>
          <p:nvPr/>
        </p:nvSpPr>
        <p:spPr bwMode="auto">
          <a:xfrm>
            <a:off x="2068514" y="5351463"/>
            <a:ext cx="785813" cy="206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23" name="AutoShape 199"/>
          <p:cNvCxnSpPr>
            <a:cxnSpLocks noChangeShapeType="1"/>
          </p:cNvCxnSpPr>
          <p:nvPr/>
        </p:nvCxnSpPr>
        <p:spPr bwMode="auto">
          <a:xfrm flipH="1">
            <a:off x="6310314" y="5092701"/>
            <a:ext cx="179388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217" name="Text Box 200"/>
          <p:cNvSpPr txBox="1">
            <a:spLocks noChangeArrowheads="1"/>
          </p:cNvSpPr>
          <p:nvPr/>
        </p:nvSpPr>
        <p:spPr bwMode="auto">
          <a:xfrm>
            <a:off x="6464302" y="4983163"/>
            <a:ext cx="785812" cy="1857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225" name="AutoShape 201"/>
          <p:cNvCxnSpPr>
            <a:cxnSpLocks noChangeShapeType="1"/>
          </p:cNvCxnSpPr>
          <p:nvPr/>
        </p:nvCxnSpPr>
        <p:spPr bwMode="auto">
          <a:xfrm flipH="1">
            <a:off x="6310314" y="5437188"/>
            <a:ext cx="179388" cy="0"/>
          </a:xfrm>
          <a:prstGeom prst="straightConnector1">
            <a:avLst/>
          </a:prstGeom>
          <a:noFill/>
          <a:ln w="1397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1218" name="Text Box 202"/>
          <p:cNvSpPr txBox="1">
            <a:spLocks noChangeArrowheads="1"/>
          </p:cNvSpPr>
          <p:nvPr/>
        </p:nvSpPr>
        <p:spPr bwMode="auto">
          <a:xfrm>
            <a:off x="6464302" y="5335588"/>
            <a:ext cx="785812" cy="206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8S rRN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20" name="TextBox 1219"/>
          <p:cNvSpPr txBox="1"/>
          <p:nvPr/>
        </p:nvSpPr>
        <p:spPr>
          <a:xfrm>
            <a:off x="2673874" y="6849031"/>
            <a:ext cx="2005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3123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89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Acrobat Document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ya</dc:creator>
  <cp:lastModifiedBy>Carita</cp:lastModifiedBy>
  <cp:revision>3</cp:revision>
  <dcterms:created xsi:type="dcterms:W3CDTF">2015-04-09T17:46:06Z</dcterms:created>
  <dcterms:modified xsi:type="dcterms:W3CDTF">2015-11-09T19:50:18Z</dcterms:modified>
</cp:coreProperties>
</file>